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312" r:id="rId2"/>
    <p:sldId id="305" r:id="rId3"/>
    <p:sldId id="313" r:id="rId4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64478"/>
    <a:srgbClr val="351432"/>
    <a:srgbClr val="9966FF"/>
    <a:srgbClr val="40B2ED"/>
    <a:srgbClr val="F38E8A"/>
    <a:srgbClr val="FFC000"/>
    <a:srgbClr val="D5FAD8"/>
    <a:srgbClr val="BBD9F2"/>
    <a:srgbClr val="929292"/>
    <a:srgbClr val="D2D1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263" autoAdjust="0"/>
    <p:restoredTop sz="94660"/>
  </p:normalViewPr>
  <p:slideViewPr>
    <p:cSldViewPr snapToGrid="0">
      <p:cViewPr>
        <p:scale>
          <a:sx n="66" d="100"/>
          <a:sy n="66" d="100"/>
        </p:scale>
        <p:origin x="2284" y="-1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54414060742407211"/>
          <c:y val="0.1388888888888889"/>
          <c:w val="0.22595463067116606"/>
          <c:h val="0.57501202974628174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Sheet5!$G$18:$G$20</c:f>
              <c:strCache>
                <c:ptCount val="3"/>
                <c:pt idx="0">
                  <c:v>Developmental growth</c:v>
                </c:pt>
                <c:pt idx="1">
                  <c:v>Root morphogenesis</c:v>
                </c:pt>
                <c:pt idx="2">
                  <c:v>Cell differentiation</c:v>
                </c:pt>
              </c:strCache>
            </c:strRef>
          </c:cat>
          <c:val>
            <c:numRef>
              <c:f>Sheet5!$H$18:$H$20</c:f>
              <c:numCache>
                <c:formatCode>General</c:formatCode>
                <c:ptCount val="3"/>
                <c:pt idx="0">
                  <c:v>4.7119443599806239</c:v>
                </c:pt>
                <c:pt idx="1">
                  <c:v>3.0055570274328738</c:v>
                </c:pt>
                <c:pt idx="2">
                  <c:v>2.78594822508232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BAF-46F9-A95E-6B419CBDE4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0"/>
        <c:axId val="2045646879"/>
        <c:axId val="2045815903"/>
      </c:barChart>
      <c:catAx>
        <c:axId val="2045646879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045815903"/>
        <c:crosses val="autoZero"/>
        <c:auto val="1"/>
        <c:lblAlgn val="ctr"/>
        <c:lblOffset val="100"/>
        <c:noMultiLvlLbl val="0"/>
      </c:catAx>
      <c:valAx>
        <c:axId val="204581590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045646879"/>
        <c:crosses val="autoZero"/>
        <c:crossBetween val="between"/>
        <c:majorUnit val="1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E37726-4B70-43A0-97FA-820C0C7CF5D6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AAF436-BC5C-4B7B-9D10-889A310B04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05976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6AAF436-BC5C-4B7B-9D10-889A310B048B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78010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C80C2F-DED2-44F8-933D-63D34F419A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6AD4B69-FC6D-4F1A-9AC2-B8350D772F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B6F9C4F-7D63-4F2F-BB94-E07D6F14C8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9E5A-E5E7-439C-8B0A-BB3A1CB82CD1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EFC7373-FC83-4222-928E-1B4AD98C4A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AA218AA-B3CE-4189-B8D2-1B76246D7F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84F5E-5677-477B-A87B-0566151442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46194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D100E2-A470-4576-B8FC-9B35B75542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441872F-3901-4FE2-9DA9-0301C0C6E1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D137E2E-A1F4-4AE6-9872-783DA091C7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9E5A-E5E7-439C-8B0A-BB3A1CB82CD1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40B42F5-52EC-40DD-BCAF-B98871DA0A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BE0BD9A-8F4F-45ED-A8DF-A5B79FE0A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84F5E-5677-477B-A87B-0566151442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33223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5EE4338-B412-4781-A12A-A79A05E1FB8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FAB1F74-43A9-42FB-A4B5-82EE1E8637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91E1E3B-DA2B-4A58-8C50-E2F3E364F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9E5A-E5E7-439C-8B0A-BB3A1CB82CD1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C36818D-0DDD-4169-BE87-A6C41E9266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047E64D-B07D-4175-98B8-C29DD53B91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84F5E-5677-477B-A87B-0566151442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0990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4F1829F-6CB1-477D-B72A-48CA6FC354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8956A85-1C03-46C7-8E81-3858262C56C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47DB57-CB07-4EDD-8C77-36AE06C301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9E5A-E5E7-439C-8B0A-BB3A1CB82CD1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339938F-411B-448A-B549-FC0951A26D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EE4C5B3-F381-491D-AEF8-F93E43B42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84F5E-5677-477B-A87B-0566151442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0846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C369D0-99E3-491E-898B-CEC17C286C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1D6ADF0-55DB-446E-B153-7A92AB93A8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51EE3CD-8276-468A-84CB-202BF0B1E9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9E5A-E5E7-439C-8B0A-BB3A1CB82CD1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A7B904F-E704-4D45-896F-ABEE226C2C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6B65E3E-1D0A-4187-87D3-E52B850DA9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84F5E-5677-477B-A87B-0566151442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1107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19B97E-7BB7-4867-AE14-A730858A3C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A45E4ED-5A61-467B-B2E6-176BDEC231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B2B1ED8-1714-48B3-896B-EC9CAAD4F0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E35C259-AC99-4507-BB92-382AEC0188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9E5A-E5E7-439C-8B0A-BB3A1CB82CD1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5EEF8C8-288C-4444-B6DB-B8725CD80A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56BAF05-0C5F-4D71-ABDE-FA2C4DF2F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84F5E-5677-477B-A87B-0566151442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58197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2764DD-DD70-4A40-AF4B-E195583BF7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5732DC2-4AD2-46D4-8560-28D2CCB815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2D6F546-5263-4D8A-90D2-9A36D2527C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273D130-A009-4172-AA52-6077DD39D8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9618CB4-74AC-4836-800F-30A8789A8EB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8137A6B-5848-46E8-BF4A-093C2DCB6F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9E5A-E5E7-439C-8B0A-BB3A1CB82CD1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99BA15C-76D5-4DE5-A6B4-94C83DEC6A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39C4EC3-6C7D-41A5-85FB-511820558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84F5E-5677-477B-A87B-0566151442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20873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C83B5F-0EE3-4992-9C28-CA69305D1A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AC35699-0D8F-45CE-B75E-CD2C2428EA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9E5A-E5E7-439C-8B0A-BB3A1CB82CD1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7A6001F-D70A-4A3C-9C50-A2A0C7E7F1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58D378C-C9BF-47DA-9038-522FCAD426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84F5E-5677-477B-A87B-0566151442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97406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7B86947-344C-4CC2-A3D3-934A003603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9E5A-E5E7-439C-8B0A-BB3A1CB82CD1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F9470E0-F78D-4FBE-8940-A8F7040676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0532923-72C5-44D4-98B9-336B2AE8EA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84F5E-5677-477B-A87B-0566151442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54834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58A5B7-A8F7-4908-89E3-A123D37CE9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BD6A2FA-0076-467F-8C3C-1B468B1C60A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CB7E1B8-F5A1-4D4B-AB6A-A6BDC6DC90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48250C0-C527-444A-8522-D3BB2375CB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9E5A-E5E7-439C-8B0A-BB3A1CB82CD1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D1FAF61-D7BD-4424-B5E6-5B5B5D8FE7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4F1D534-2E25-4E03-8F41-722CAC747A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84F5E-5677-477B-A87B-0566151442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3423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4575240-9CC5-40D1-A7CE-32F90932D3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A18AD5C-17C9-4847-A5F9-70BA2408939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D7E2548-A095-420F-92A4-D000D44D29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0DF1CBD-A0C3-4C84-8387-7EC19B2DBB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59E5A-E5E7-439C-8B0A-BB3A1CB82CD1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917AF81-CF90-4ACB-87B4-FD427A44E2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6B14985-4093-4EA8-8761-26CEE17BB5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84F5E-5677-477B-A87B-0566151442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848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154ADD0-C46E-4440-A276-7EC394BDAC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C74D299-FDA2-425B-8398-E3BD94926F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9B27F6-DBE2-4933-A765-1AF8AADC83E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359E5A-E5E7-439C-8B0A-BB3A1CB82CD1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8E0A7CC-21F1-4F0A-A17F-E15D8FB4AD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C4181E1-BB5A-43D2-B845-DD5DDE0A772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C84F5E-5677-477B-A87B-0566151442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9702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tif"/><Relationship Id="rId5" Type="http://schemas.microsoft.com/office/2007/relationships/hdphoto" Target="../media/hdphoto1.wdp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组合 17">
            <a:extLst>
              <a:ext uri="{FF2B5EF4-FFF2-40B4-BE49-F238E27FC236}">
                <a16:creationId xmlns:a16="http://schemas.microsoft.com/office/drawing/2014/main" id="{FF5FF3DE-81B0-4A73-A347-B80E22E9539A}"/>
              </a:ext>
            </a:extLst>
          </p:cNvPr>
          <p:cNvGrpSpPr/>
          <p:nvPr/>
        </p:nvGrpSpPr>
        <p:grpSpPr>
          <a:xfrm>
            <a:off x="1991327" y="1845563"/>
            <a:ext cx="2885472" cy="3527737"/>
            <a:chOff x="2674684" y="572018"/>
            <a:chExt cx="3165844" cy="3913343"/>
          </a:xfrm>
        </p:grpSpPr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689764D7-57C6-477C-8CF0-F8ADA32A968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40529" y="2458774"/>
              <a:ext cx="899999" cy="2005761"/>
            </a:xfrm>
            <a:prstGeom prst="rect">
              <a:avLst/>
            </a:prstGeom>
          </p:spPr>
        </p:pic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8B812BB5-9CC2-4388-8D0F-62502640F3E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85106" y="2458774"/>
              <a:ext cx="899999" cy="2026587"/>
            </a:xfrm>
            <a:prstGeom prst="rect">
              <a:avLst/>
            </a:prstGeom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DEEBC565-7044-405E-8815-DB4FF5BD053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62817" y="2463118"/>
              <a:ext cx="899999" cy="2017897"/>
            </a:xfrm>
            <a:prstGeom prst="rect">
              <a:avLst/>
            </a:prstGeom>
          </p:spPr>
        </p:pic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8D1D498F-8852-4924-B73F-BA794A6F93C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40529" y="767243"/>
              <a:ext cx="899999" cy="1611190"/>
            </a:xfrm>
            <a:prstGeom prst="rect">
              <a:avLst/>
            </a:prstGeom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DEBECFC4-6BCB-47E4-A200-E32382B7419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85106" y="775648"/>
              <a:ext cx="899999" cy="1616844"/>
            </a:xfrm>
            <a:prstGeom prst="rect">
              <a:avLst/>
            </a:prstGeom>
          </p:spPr>
        </p:pic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6D1C2FC8-0A9E-42FC-99AB-7B0F57C6301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62817" y="775648"/>
              <a:ext cx="899999" cy="1602784"/>
            </a:xfrm>
            <a:prstGeom prst="rect">
              <a:avLst/>
            </a:prstGeom>
          </p:spPr>
        </p:pic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BBE29D06-4F4C-4C86-876E-ECE622B44F84}"/>
                </a:ext>
              </a:extLst>
            </p:cNvPr>
            <p:cNvSpPr txBox="1"/>
            <p:nvPr/>
          </p:nvSpPr>
          <p:spPr>
            <a:xfrm rot="16200000">
              <a:off x="2151737" y="3082830"/>
              <a:ext cx="1282271" cy="2363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LT2</a:t>
              </a:r>
              <a:r>
                <a:rPr lang="en-US" altLang="zh-CN" sz="8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pro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:PLT2-YFP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">
              <a:extLst>
                <a:ext uri="{FF2B5EF4-FFF2-40B4-BE49-F238E27FC236}">
                  <a16:creationId xmlns:a16="http://schemas.microsoft.com/office/drawing/2014/main" id="{6685B132-C858-4A34-9183-019E5656D1E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112970" y="572018"/>
              <a:ext cx="57100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800" dirty="0">
                  <a:cs typeface="Arial" panose="020B0604020202020204" pitchFamily="34" charset="0"/>
                </a:rPr>
                <a:t>Merge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28" name="TextBox 2">
              <a:extLst>
                <a:ext uri="{FF2B5EF4-FFF2-40B4-BE49-F238E27FC236}">
                  <a16:creationId xmlns:a16="http://schemas.microsoft.com/office/drawing/2014/main" id="{929381A9-D9EB-428B-83D4-F23266939AD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47348" y="572018"/>
              <a:ext cx="89440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800" dirty="0">
                  <a:cs typeface="Arial" panose="020B0604020202020204" pitchFamily="34" charset="0"/>
                </a:rPr>
                <a:t>Fluorescence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29" name="TextBox 2">
              <a:extLst>
                <a:ext uri="{FF2B5EF4-FFF2-40B4-BE49-F238E27FC236}">
                  <a16:creationId xmlns:a16="http://schemas.microsoft.com/office/drawing/2014/main" id="{93B47F9B-3E70-4F11-9EBE-5A64F7E38BB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57670" y="583241"/>
              <a:ext cx="31464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800" dirty="0">
                  <a:cs typeface="Arial" panose="020B0604020202020204" pitchFamily="34" charset="0"/>
                </a:rPr>
                <a:t>PI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</p:grpSp>
      <p:sp>
        <p:nvSpPr>
          <p:cNvPr id="5" name="文本框 9">
            <a:extLst>
              <a:ext uri="{FF2B5EF4-FFF2-40B4-BE49-F238E27FC236}">
                <a16:creationId xmlns:a16="http://schemas.microsoft.com/office/drawing/2014/main" id="{34E828A1-41A6-9ACA-7A2D-53A50D27FFF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5643" y="5521899"/>
            <a:ext cx="5484813" cy="13849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MS PGothic" charset="-128"/>
                <a:cs typeface="宋体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  <a:cs typeface="宋体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  <a:cs typeface="宋体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  <a:cs typeface="宋体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  <a:cs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  <a:cs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  <a:cs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  <a:cs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  <a:cs typeface="宋体" charset="-122"/>
              </a:defRPr>
            </a:lvl9pPr>
          </a:lstStyle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 1</a:t>
            </a: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he expression pattern of </a:t>
            </a:r>
            <a:r>
              <a:rPr kumimoji="0" lang="en-US" altLang="zh-CN" sz="1200" i="1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LT1 </a:t>
            </a:r>
            <a:r>
              <a:rPr kumimoji="0" lang="en-US" altLang="zh-CN" sz="120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nd</a:t>
            </a:r>
            <a:r>
              <a:rPr kumimoji="0" lang="en-US" altLang="zh-CN" sz="1200" i="1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LT2 </a:t>
            </a:r>
            <a:r>
              <a:rPr kumimoji="0" lang="en-US" altLang="zh-CN" sz="120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n the roots of </a:t>
            </a:r>
            <a:r>
              <a:rPr kumimoji="0" lang="en-US" altLang="zh-CN" sz="120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rabidopsis</a:t>
            </a:r>
            <a:r>
              <a:rPr kumimoji="0" lang="en-US" altLang="zh-CN" sz="120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 </a:t>
            </a:r>
            <a:r>
              <a:rPr kumimoji="0" lang="en-US" altLang="zh-CN" sz="1200" b="0" i="1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LT1</a:t>
            </a:r>
            <a:r>
              <a:rPr kumimoji="0" lang="en-US" altLang="zh-CN" sz="1200" b="0" i="1" u="none" strike="noStrike" kern="1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ro</a:t>
            </a:r>
            <a:r>
              <a:rPr kumimoji="0" lang="en-US" altLang="zh-CN" sz="1200" b="0" i="1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:PLT1-YFP/</a:t>
            </a:r>
            <a:r>
              <a:rPr kumimoji="0" lang="en-US" altLang="zh-CN" sz="1200" b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l-0</a:t>
            </a:r>
            <a:r>
              <a:rPr kumimoji="0" lang="en-US" altLang="zh-CN" sz="1200" b="0" i="1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200" b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nd</a:t>
            </a:r>
            <a:r>
              <a:rPr kumimoji="0" lang="en-US" altLang="zh-CN" sz="1200" b="0" i="1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LT2</a:t>
            </a:r>
            <a:r>
              <a:rPr kumimoji="0" lang="en-US" altLang="zh-CN" sz="1200" b="0" i="1" u="none" strike="noStrike" kern="1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ro</a:t>
            </a:r>
            <a:r>
              <a:rPr kumimoji="0" lang="en-US" altLang="zh-CN" sz="1200" b="0" i="1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:PLT2-YFP/</a:t>
            </a:r>
            <a:r>
              <a:rPr lang="en-US" altLang="zh-CN" sz="1200" kern="100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l-0 </a:t>
            </a:r>
            <a:r>
              <a:rPr kumimoji="0" lang="en-US" altLang="zh-CN" sz="12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ransgenic plants were grown for 7 days, and the fluorescence signal in the roots was detected by fluorescence confocal microscope (FV3000). The yellow fluorescence channel was the excitation of the YFP fluorescence signal at 514 nm. </a:t>
            </a:r>
            <a:r>
              <a:rPr kumimoji="0" lang="en-GB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cale bar, </a:t>
            </a:r>
            <a:r>
              <a:rPr kumimoji="0" lang="en-US" altLang="zh-CN" sz="12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100 </a:t>
            </a:r>
            <a:r>
              <a:rPr kumimoji="0" lang="en-US" altLang="zh-CN" sz="1200" b="0" i="0" u="none" strike="noStrike" kern="1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μm</a:t>
            </a:r>
            <a:r>
              <a:rPr kumimoji="0" lang="en-US" altLang="zh-CN" sz="12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80397D8-584E-59AE-79D4-403821752A17}"/>
              </a:ext>
            </a:extLst>
          </p:cNvPr>
          <p:cNvSpPr txBox="1"/>
          <p:nvPr/>
        </p:nvSpPr>
        <p:spPr>
          <a:xfrm rot="16200000">
            <a:off x="1521089" y="2640940"/>
            <a:ext cx="1155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PLT1</a:t>
            </a:r>
            <a:r>
              <a:rPr lang="en-US" altLang="zh-CN" sz="8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pro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:PLT1-YFP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96475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>
            <a:extLst>
              <a:ext uri="{FF2B5EF4-FFF2-40B4-BE49-F238E27FC236}">
                <a16:creationId xmlns:a16="http://schemas.microsoft.com/office/drawing/2014/main" id="{6F80E450-894E-4782-6D05-6F1E1B05C597}"/>
              </a:ext>
            </a:extLst>
          </p:cNvPr>
          <p:cNvGrpSpPr/>
          <p:nvPr/>
        </p:nvGrpSpPr>
        <p:grpSpPr>
          <a:xfrm>
            <a:off x="1966625" y="1121574"/>
            <a:ext cx="2865725" cy="3122012"/>
            <a:chOff x="2169824" y="1085478"/>
            <a:chExt cx="2865725" cy="3122012"/>
          </a:xfrm>
        </p:grpSpPr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DCC43CEE-8A3D-4902-BDB5-03145E6B39E8}"/>
                </a:ext>
              </a:extLst>
            </p:cNvPr>
            <p:cNvSpPr txBox="1"/>
            <p:nvPr/>
          </p:nvSpPr>
          <p:spPr>
            <a:xfrm>
              <a:off x="2261381" y="1085478"/>
              <a:ext cx="2504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200" b="1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B8C91115-9472-4AE5-BCFA-87BB3EE13EFA}"/>
                </a:ext>
              </a:extLst>
            </p:cNvPr>
            <p:cNvSpPr txBox="1"/>
            <p:nvPr/>
          </p:nvSpPr>
          <p:spPr>
            <a:xfrm>
              <a:off x="2261381" y="2784586"/>
              <a:ext cx="2504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200" b="1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1C39DDE8-8301-4812-BA42-D44067893D72}"/>
                </a:ext>
              </a:extLst>
            </p:cNvPr>
            <p:cNvSpPr txBox="1"/>
            <p:nvPr/>
          </p:nvSpPr>
          <p:spPr>
            <a:xfrm>
              <a:off x="2169824" y="3437153"/>
              <a:ext cx="8851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α-GFP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B78D2199-DD63-45BB-8C28-CCCA3EFAFD82}"/>
                </a:ext>
              </a:extLst>
            </p:cNvPr>
            <p:cNvSpPr txBox="1"/>
            <p:nvPr/>
          </p:nvSpPr>
          <p:spPr>
            <a:xfrm>
              <a:off x="2169824" y="3738506"/>
              <a:ext cx="8851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α-Tubuli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19A5BBBD-A1E8-45B4-89C1-B1D36856AF72}"/>
                </a:ext>
              </a:extLst>
            </p:cNvPr>
            <p:cNvSpPr txBox="1"/>
            <p:nvPr/>
          </p:nvSpPr>
          <p:spPr>
            <a:xfrm>
              <a:off x="2169824" y="3979724"/>
              <a:ext cx="8851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Ponceau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C91FBFE3-376E-3C55-7620-C4762B1AE166}"/>
                </a:ext>
              </a:extLst>
            </p:cNvPr>
            <p:cNvGrpSpPr/>
            <p:nvPr/>
          </p:nvGrpSpPr>
          <p:grpSpPr>
            <a:xfrm>
              <a:off x="3002699" y="3053177"/>
              <a:ext cx="2032850" cy="1154313"/>
              <a:chOff x="3002699" y="3053177"/>
              <a:chExt cx="2032850" cy="1154313"/>
            </a:xfrm>
          </p:grpSpPr>
          <p:grpSp>
            <p:nvGrpSpPr>
              <p:cNvPr id="5" name="组合 4">
                <a:extLst>
                  <a:ext uri="{FF2B5EF4-FFF2-40B4-BE49-F238E27FC236}">
                    <a16:creationId xmlns:a16="http://schemas.microsoft.com/office/drawing/2014/main" id="{A9102BF8-30F0-61EC-F101-627DC94205D3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002699" y="3432904"/>
                <a:ext cx="1364400" cy="774586"/>
                <a:chOff x="2839307" y="3230991"/>
                <a:chExt cx="1610049" cy="914044"/>
              </a:xfrm>
            </p:grpSpPr>
            <p:pic>
              <p:nvPicPr>
                <p:cNvPr id="26" name="图片 25" descr="图片包含 背景图案&#10;&#10;描述已自动生成">
                  <a:extLst>
                    <a:ext uri="{FF2B5EF4-FFF2-40B4-BE49-F238E27FC236}">
                      <a16:creationId xmlns:a16="http://schemas.microsoft.com/office/drawing/2014/main" id="{F931EC86-5AF8-47B7-8C95-9B982C48EF6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39307" y="3230991"/>
                  <a:ext cx="1610049" cy="272186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pic>
              <p:nvPicPr>
                <p:cNvPr id="27" name="图片 26" descr="图片包含 游戏机&#10;&#10;描述已自动生成">
                  <a:extLst>
                    <a:ext uri="{FF2B5EF4-FFF2-40B4-BE49-F238E27FC236}">
                      <a16:creationId xmlns:a16="http://schemas.microsoft.com/office/drawing/2014/main" id="{BF492762-F540-4CAE-B711-3C4D9395D45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39307" y="3553470"/>
                  <a:ext cx="1609200" cy="308324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pic>
              <p:nvPicPr>
                <p:cNvPr id="28" name="图片 27" descr="紫色的卡通人物&#10;&#10;低可信度描述已自动生成">
                  <a:extLst>
                    <a:ext uri="{FF2B5EF4-FFF2-40B4-BE49-F238E27FC236}">
                      <a16:creationId xmlns:a16="http://schemas.microsoft.com/office/drawing/2014/main" id="{8965F2B9-DACA-4718-95C0-4E20FB2BC98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-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39307" y="3912088"/>
                  <a:ext cx="1609200" cy="232947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</p:grp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87E46C20-0FD1-4F14-AB8F-6268077AEB9A}"/>
                  </a:ext>
                </a:extLst>
              </p:cNvPr>
              <p:cNvSpPr txBox="1"/>
              <p:nvPr/>
            </p:nvSpPr>
            <p:spPr>
              <a:xfrm rot="19712182">
                <a:off x="3025205" y="3097743"/>
                <a:ext cx="83363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l-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33A18720-D803-400C-8B34-06A277C176DF}"/>
                  </a:ext>
                </a:extLst>
              </p:cNvPr>
              <p:cNvSpPr txBox="1"/>
              <p:nvPr/>
            </p:nvSpPr>
            <p:spPr>
              <a:xfrm rot="19764622">
                <a:off x="3387069" y="3086013"/>
                <a:ext cx="83363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bes1-D</a:t>
                </a:r>
                <a:endParaRPr lang="zh-CN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691A7597-7AB8-4056-8D40-6CE026023679}"/>
                  </a:ext>
                </a:extLst>
              </p:cNvPr>
              <p:cNvSpPr txBox="1"/>
              <p:nvPr/>
            </p:nvSpPr>
            <p:spPr>
              <a:xfrm rot="19712182">
                <a:off x="3722877" y="3088831"/>
                <a:ext cx="83363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LT2-OX</a:t>
                </a:r>
                <a:endParaRPr lang="zh-CN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FF8F198E-E313-47CB-9504-84CD29882CA0}"/>
                  </a:ext>
                </a:extLst>
              </p:cNvPr>
              <p:cNvSpPr txBox="1"/>
              <p:nvPr/>
            </p:nvSpPr>
            <p:spPr>
              <a:xfrm rot="19712182">
                <a:off x="4067351" y="3053177"/>
                <a:ext cx="96819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LT2-OX/bes1-D</a:t>
                </a:r>
                <a:endParaRPr lang="zh-CN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4FF114A9-5929-473E-A2DC-9047BEDBA330}"/>
                </a:ext>
              </a:extLst>
            </p:cNvPr>
            <p:cNvSpPr txBox="1"/>
            <p:nvPr/>
          </p:nvSpPr>
          <p:spPr>
            <a:xfrm rot="19712182">
              <a:off x="3012185" y="1423672"/>
              <a:ext cx="8336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ol-0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5A30F5E3-7BB5-42CB-B2BD-D52B51B21ECE}"/>
                </a:ext>
              </a:extLst>
            </p:cNvPr>
            <p:cNvSpPr txBox="1"/>
            <p:nvPr/>
          </p:nvSpPr>
          <p:spPr>
            <a:xfrm rot="19764622">
              <a:off x="3671274" y="1418469"/>
              <a:ext cx="8336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bes1-D</a:t>
              </a:r>
              <a:endParaRPr kumimoji="0" lang="zh-CN" altLang="en-US" sz="8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8C7D35D9-D462-463E-828D-CEC827D34605}"/>
                </a:ext>
              </a:extLst>
            </p:cNvPr>
            <p:cNvSpPr txBox="1"/>
            <p:nvPr/>
          </p:nvSpPr>
          <p:spPr>
            <a:xfrm rot="19712182">
              <a:off x="4053308" y="1357869"/>
              <a:ext cx="9681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PLT2-OX/bes1-D</a:t>
              </a:r>
              <a:endParaRPr kumimoji="0" lang="zh-CN" altLang="en-US" sz="8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E61CC909-ED49-405D-9E3E-F54F657E45FA}"/>
                </a:ext>
              </a:extLst>
            </p:cNvPr>
            <p:cNvSpPr txBox="1"/>
            <p:nvPr/>
          </p:nvSpPr>
          <p:spPr>
            <a:xfrm rot="19712182">
              <a:off x="3347450" y="1412691"/>
              <a:ext cx="8336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PLT2-OX</a:t>
              </a:r>
              <a:endParaRPr kumimoji="0" lang="zh-CN" altLang="en-US" sz="8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DB589243-F18E-4FB4-ADF6-5F72E330C303}"/>
                </a:ext>
              </a:extLst>
            </p:cNvPr>
            <p:cNvSpPr txBox="1"/>
            <p:nvPr/>
          </p:nvSpPr>
          <p:spPr>
            <a:xfrm>
              <a:off x="2476591" y="2068752"/>
              <a:ext cx="5093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120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C2573FDA-0A69-4076-8451-8C5F8DB2C930}"/>
                </a:ext>
              </a:extLst>
            </p:cNvPr>
            <p:cNvSpPr txBox="1"/>
            <p:nvPr/>
          </p:nvSpPr>
          <p:spPr>
            <a:xfrm>
              <a:off x="2624506" y="1988298"/>
              <a:ext cx="3614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200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2735F909-7924-444E-A760-EBE5D58626A1}"/>
                </a:ext>
              </a:extLst>
            </p:cNvPr>
            <p:cNvSpPr txBox="1"/>
            <p:nvPr/>
          </p:nvSpPr>
          <p:spPr>
            <a:xfrm>
              <a:off x="2581271" y="2147730"/>
              <a:ext cx="40465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80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0828EC68-BDD4-4B3A-879E-B9F21CC0A025}"/>
                </a:ext>
              </a:extLst>
            </p:cNvPr>
            <p:cNvSpPr txBox="1"/>
            <p:nvPr/>
          </p:nvSpPr>
          <p:spPr>
            <a:xfrm>
              <a:off x="2654085" y="2234166"/>
              <a:ext cx="33183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50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2E78FEB2-743C-48BB-BF64-BC66B9F1E098}"/>
                </a:ext>
              </a:extLst>
            </p:cNvPr>
            <p:cNvSpPr txBox="1"/>
            <p:nvPr/>
          </p:nvSpPr>
          <p:spPr>
            <a:xfrm>
              <a:off x="2476591" y="2369829"/>
              <a:ext cx="5093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200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DD1DA7EE-38D3-C63B-DC35-689C92B2918F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920714" y="1765340"/>
              <a:ext cx="1446385" cy="834129"/>
              <a:chOff x="2804934" y="1698365"/>
              <a:chExt cx="1194947" cy="689125"/>
            </a:xfrm>
          </p:grpSpPr>
          <p:pic>
            <p:nvPicPr>
              <p:cNvPr id="37" name="图片 36" descr="模糊的黑白照&#10;&#10;中度可信度描述已自动生成">
                <a:extLst>
                  <a:ext uri="{FF2B5EF4-FFF2-40B4-BE49-F238E27FC236}">
                    <a16:creationId xmlns:a16="http://schemas.microsoft.com/office/drawing/2014/main" id="{6E6CEE01-E347-4AED-84B8-671F2A9EC1E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8502"/>
              <a:stretch/>
            </p:blipFill>
            <p:spPr>
              <a:xfrm>
                <a:off x="2873440" y="1698365"/>
                <a:ext cx="1126441" cy="689125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cxnSp>
            <p:nvCxnSpPr>
              <p:cNvPr id="3" name="直接连接符 2">
                <a:extLst>
                  <a:ext uri="{FF2B5EF4-FFF2-40B4-BE49-F238E27FC236}">
                    <a16:creationId xmlns:a16="http://schemas.microsoft.com/office/drawing/2014/main" id="{05EAC3FE-D7CA-4C3D-9F22-E550B2C8A68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04934" y="2039053"/>
                <a:ext cx="6429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直接连接符 54">
                <a:extLst>
                  <a:ext uri="{FF2B5EF4-FFF2-40B4-BE49-F238E27FC236}">
                    <a16:creationId xmlns:a16="http://schemas.microsoft.com/office/drawing/2014/main" id="{2B085A2A-935C-4F3B-A156-1D1CF68ADB8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04934" y="2098085"/>
                <a:ext cx="6429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直接连接符 56">
                <a:extLst>
                  <a:ext uri="{FF2B5EF4-FFF2-40B4-BE49-F238E27FC236}">
                    <a16:creationId xmlns:a16="http://schemas.microsoft.com/office/drawing/2014/main" id="{B51EA556-5F35-4B76-A218-B45AAA0B2C0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04934" y="2147391"/>
                <a:ext cx="6429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直接连接符 57">
                <a:extLst>
                  <a:ext uri="{FF2B5EF4-FFF2-40B4-BE49-F238E27FC236}">
                    <a16:creationId xmlns:a16="http://schemas.microsoft.com/office/drawing/2014/main" id="{7CE51D85-B805-49AE-877D-4FEA4C72687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04934" y="2257561"/>
                <a:ext cx="6429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直接连接符 58">
                <a:extLst>
                  <a:ext uri="{FF2B5EF4-FFF2-40B4-BE49-F238E27FC236}">
                    <a16:creationId xmlns:a16="http://schemas.microsoft.com/office/drawing/2014/main" id="{449AD32A-9153-4A5D-83FB-C7B8DBE805D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04934" y="1969576"/>
                <a:ext cx="6429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A1DAFBD2-F66D-C4E3-0238-67886FAF6123}"/>
                </a:ext>
              </a:extLst>
            </p:cNvPr>
            <p:cNvSpPr txBox="1"/>
            <p:nvPr/>
          </p:nvSpPr>
          <p:spPr>
            <a:xfrm>
              <a:off x="2628474" y="1855589"/>
              <a:ext cx="3614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6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bp</a:t>
              </a:r>
              <a:endParaRPr kumimoji="0" lang="zh-CN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sp>
        <p:nvSpPr>
          <p:cNvPr id="9" name="文本框 9">
            <a:extLst>
              <a:ext uri="{FF2B5EF4-FFF2-40B4-BE49-F238E27FC236}">
                <a16:creationId xmlns:a16="http://schemas.microsoft.com/office/drawing/2014/main" id="{6717816F-3013-F3FC-7761-9E15E51B6E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6593" y="4587889"/>
            <a:ext cx="5484813" cy="19389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MS PGothic" charset="-128"/>
                <a:cs typeface="宋体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  <a:cs typeface="宋体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  <a:cs typeface="宋体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  <a:cs typeface="宋体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  <a:cs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  <a:cs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  <a:cs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  <a:cs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  <a:cs typeface="宋体" charset="-122"/>
              </a:defRPr>
            </a:lvl9pPr>
          </a:lstStyle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 2</a:t>
            </a:r>
          </a:p>
          <a:p>
            <a:pPr lvl="0" algn="just">
              <a:spcBef>
                <a:spcPts val="0"/>
              </a:spcBef>
              <a:buNone/>
              <a:defRPr/>
            </a:pPr>
            <a:r>
              <a:rPr kumimoji="0" lang="en-US" altLang="zh-CN" sz="120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ackground identification of </a:t>
            </a:r>
            <a:r>
              <a:rPr kumimoji="0" lang="en-US" altLang="zh-CN" sz="1200" i="1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LT2-OX/bes1-D. </a:t>
            </a:r>
            <a:r>
              <a:rPr kumimoji="0" lang="en-US" altLang="zh-CN" sz="120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</a:t>
            </a:r>
            <a:r>
              <a:rPr lang="en-US" altLang="zh-CN" sz="1200" b="1" kern="100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</a:t>
            </a:r>
            <a:r>
              <a:rPr kumimoji="0" lang="en-US" altLang="zh-CN" sz="120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)</a:t>
            </a:r>
            <a:r>
              <a:rPr kumimoji="0" lang="en-US" altLang="zh-CN" sz="12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GB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he gel shows the genotyping identification of Col-0, </a:t>
            </a:r>
            <a:r>
              <a:rPr kumimoji="0" lang="en-GB" altLang="zh-CN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LT2-OX</a:t>
            </a:r>
            <a:r>
              <a:rPr kumimoji="0" lang="en-GB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</a:t>
            </a:r>
            <a:r>
              <a:rPr kumimoji="0" lang="en-GB" altLang="zh-CN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es1-D</a:t>
            </a:r>
            <a:r>
              <a:rPr kumimoji="0" lang="en-GB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and </a:t>
            </a:r>
            <a:r>
              <a:rPr kumimoji="0" lang="en-GB" altLang="zh-CN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LT2-OX/bes1-D </a:t>
            </a:r>
            <a:r>
              <a:rPr kumimoji="0" lang="en-GB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lants.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bes1-D</a:t>
            </a:r>
            <a:r>
              <a:rPr kumimoji="0" lang="en-GB" altLang="zh-CN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GB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enotyping identification method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as described in the Materials and Methods. </a:t>
            </a:r>
            <a:r>
              <a:rPr kumimoji="0" lang="en-US" altLang="zh-CN" sz="120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</a:t>
            </a:r>
            <a:r>
              <a:rPr lang="en-US" altLang="zh-CN" sz="1200" b="1" kern="100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</a:t>
            </a:r>
            <a:r>
              <a:rPr kumimoji="0" lang="en-US" altLang="zh-CN" sz="120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) </a:t>
            </a:r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e abundance of PLT2-GFP in the roots of 10-day-old seedings from </a:t>
            </a:r>
            <a:r>
              <a:rPr kumimoji="0" lang="en-GB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l-0, </a:t>
            </a:r>
            <a:r>
              <a:rPr kumimoji="0" lang="en-GB" altLang="zh-CN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LT2-OX</a:t>
            </a:r>
            <a:r>
              <a:rPr kumimoji="0" lang="en-GB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</a:t>
            </a:r>
            <a:r>
              <a:rPr kumimoji="0" lang="en-GB" altLang="zh-CN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es1-D</a:t>
            </a:r>
            <a:r>
              <a:rPr kumimoji="0" lang="en-GB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and </a:t>
            </a:r>
            <a:r>
              <a:rPr kumimoji="0" lang="en-GB" altLang="zh-CN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LT2-OX/bes1-D </a:t>
            </a:r>
            <a:r>
              <a:rPr kumimoji="0" lang="en-GB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lants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. </a:t>
            </a:r>
          </a:p>
          <a:p>
            <a:pPr lvl="0" algn="just">
              <a:spcBef>
                <a:spcPts val="0"/>
              </a:spcBef>
              <a:buNone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he immunoblot signal ratio between PLT2-GFP and Tubulin bands in </a:t>
            </a:r>
            <a:r>
              <a:rPr kumimoji="0" lang="en-US" altLang="zh-CN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LT2-OX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and </a:t>
            </a:r>
            <a:r>
              <a:rPr kumimoji="0" lang="en-US" altLang="zh-CN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LT2-OX/bes1-D 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lants quantified </a:t>
            </a:r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y </a:t>
            </a:r>
            <a:r>
              <a:rPr lang="en-US" altLang="zh-CN" sz="1200" dirty="0" err="1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Vilber</a:t>
            </a:r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Fusion 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oftware showed at the bottom.</a:t>
            </a:r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GB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onceau S staining of the Rubisco large subunit and </a:t>
            </a:r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ti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tubulin immunoblot </a:t>
            </a:r>
            <a:r>
              <a:rPr kumimoji="0" lang="en-GB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were used as an equal loading control.</a:t>
            </a:r>
            <a:endParaRPr kumimoji="0" lang="en-US" altLang="zh-CN" sz="1200" b="0" i="1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E55C743C-08A7-0DE5-1824-981D85957271}"/>
              </a:ext>
            </a:extLst>
          </p:cNvPr>
          <p:cNvSpPr txBox="1"/>
          <p:nvPr/>
        </p:nvSpPr>
        <p:spPr>
          <a:xfrm>
            <a:off x="3149308" y="4267271"/>
            <a:ext cx="10138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      0.9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08948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组合 16">
            <a:extLst>
              <a:ext uri="{FF2B5EF4-FFF2-40B4-BE49-F238E27FC236}">
                <a16:creationId xmlns:a16="http://schemas.microsoft.com/office/drawing/2014/main" id="{BB12A91B-91A6-8223-ABD6-BC477135554D}"/>
              </a:ext>
            </a:extLst>
          </p:cNvPr>
          <p:cNvGrpSpPr/>
          <p:nvPr/>
        </p:nvGrpSpPr>
        <p:grpSpPr>
          <a:xfrm>
            <a:off x="3340534" y="2178517"/>
            <a:ext cx="2667000" cy="1828800"/>
            <a:chOff x="3929863" y="1936244"/>
            <a:chExt cx="2667000" cy="1828800"/>
          </a:xfrm>
        </p:grpSpPr>
        <p:graphicFrame>
          <p:nvGraphicFramePr>
            <p:cNvPr id="3" name="图表 2">
              <a:extLst>
                <a:ext uri="{FF2B5EF4-FFF2-40B4-BE49-F238E27FC236}">
                  <a16:creationId xmlns:a16="http://schemas.microsoft.com/office/drawing/2014/main" id="{19492783-5992-14C7-DC4C-D77709C2BD3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74428561"/>
                </p:ext>
              </p:extLst>
            </p:nvPr>
          </p:nvGraphicFramePr>
          <p:xfrm>
            <a:off x="3929863" y="1936244"/>
            <a:ext cx="2667000" cy="182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47BE4F74-711B-FFD8-52C4-39F1008E7378}"/>
                </a:ext>
              </a:extLst>
            </p:cNvPr>
            <p:cNvSpPr txBox="1"/>
            <p:nvPr/>
          </p:nvSpPr>
          <p:spPr>
            <a:xfrm>
              <a:off x="5248209" y="3406514"/>
              <a:ext cx="880164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rtl="0">
                <a:defRPr sz="1400" b="0" i="0" u="none" strike="noStrike" kern="1200" spc="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log</a:t>
              </a:r>
              <a:r>
                <a:rPr lang="en-US" altLang="zh-CN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zh-CN" sz="800" baseline="20000" dirty="0">
                  <a:latin typeface="Arial" panose="020B0604020202020204" pitchFamily="34" charset="0"/>
                  <a:cs typeface="Arial" panose="020B0604020202020204" pitchFamily="34" charset="0"/>
                </a:rPr>
                <a:t>P-value</a:t>
              </a:r>
            </a:p>
          </p:txBody>
        </p:sp>
      </p:grpSp>
      <p:sp>
        <p:nvSpPr>
          <p:cNvPr id="9" name="文本框 8">
            <a:extLst>
              <a:ext uri="{FF2B5EF4-FFF2-40B4-BE49-F238E27FC236}">
                <a16:creationId xmlns:a16="http://schemas.microsoft.com/office/drawing/2014/main" id="{6270446E-85C1-091E-78DA-C10AF0B85DFC}"/>
              </a:ext>
            </a:extLst>
          </p:cNvPr>
          <p:cNvSpPr txBox="1"/>
          <p:nvPr/>
        </p:nvSpPr>
        <p:spPr>
          <a:xfrm>
            <a:off x="1067470" y="1896269"/>
            <a:ext cx="2504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1C4BBB2-A995-602B-C4A0-38C5202EF4FF}"/>
              </a:ext>
            </a:extLst>
          </p:cNvPr>
          <p:cNvSpPr txBox="1"/>
          <p:nvPr/>
        </p:nvSpPr>
        <p:spPr>
          <a:xfrm>
            <a:off x="3460758" y="1913017"/>
            <a:ext cx="2504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椭圆 20">
            <a:extLst>
              <a:ext uri="{FF2B5EF4-FFF2-40B4-BE49-F238E27FC236}">
                <a16:creationId xmlns:a16="http://schemas.microsoft.com/office/drawing/2014/main" id="{BC259A10-87D1-C2A5-BEBD-58733104B459}"/>
              </a:ext>
            </a:extLst>
          </p:cNvPr>
          <p:cNvSpPr/>
          <p:nvPr/>
        </p:nvSpPr>
        <p:spPr>
          <a:xfrm rot="19251659">
            <a:off x="1785612" y="2597358"/>
            <a:ext cx="1345136" cy="738630"/>
          </a:xfrm>
          <a:prstGeom prst="ellipse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2" name="椭圆 21">
            <a:extLst>
              <a:ext uri="{FF2B5EF4-FFF2-40B4-BE49-F238E27FC236}">
                <a16:creationId xmlns:a16="http://schemas.microsoft.com/office/drawing/2014/main" id="{051B6FB1-9C82-22B2-AEFC-1CECF0B6B748}"/>
              </a:ext>
            </a:extLst>
          </p:cNvPr>
          <p:cNvSpPr/>
          <p:nvPr/>
        </p:nvSpPr>
        <p:spPr>
          <a:xfrm rot="19640646">
            <a:off x="2048046" y="2811281"/>
            <a:ext cx="1345136" cy="73863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3" name="椭圆 22">
            <a:extLst>
              <a:ext uri="{FF2B5EF4-FFF2-40B4-BE49-F238E27FC236}">
                <a16:creationId xmlns:a16="http://schemas.microsoft.com/office/drawing/2014/main" id="{BEC41026-0D3A-F213-DBF7-961104468D7D}"/>
              </a:ext>
            </a:extLst>
          </p:cNvPr>
          <p:cNvSpPr/>
          <p:nvPr/>
        </p:nvSpPr>
        <p:spPr>
          <a:xfrm rot="12966042">
            <a:off x="1475363" y="2792804"/>
            <a:ext cx="1345136" cy="738630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4" name="椭圆 23">
            <a:extLst>
              <a:ext uri="{FF2B5EF4-FFF2-40B4-BE49-F238E27FC236}">
                <a16:creationId xmlns:a16="http://schemas.microsoft.com/office/drawing/2014/main" id="{CECEF27C-DDA3-5122-E837-5544F097861C}"/>
              </a:ext>
            </a:extLst>
          </p:cNvPr>
          <p:cNvSpPr/>
          <p:nvPr/>
        </p:nvSpPr>
        <p:spPr>
          <a:xfrm rot="13406715">
            <a:off x="1756140" y="2592789"/>
            <a:ext cx="1345136" cy="738630"/>
          </a:xfrm>
          <a:prstGeom prst="ellipse">
            <a:avLst/>
          </a:prstGeom>
          <a:noFill/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F1BD4DDB-C5CA-9E6E-7A8D-59CF40CF8DAE}"/>
              </a:ext>
            </a:extLst>
          </p:cNvPr>
          <p:cNvSpPr txBox="1"/>
          <p:nvPr/>
        </p:nvSpPr>
        <p:spPr>
          <a:xfrm>
            <a:off x="1998572" y="2504300"/>
            <a:ext cx="2232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78D14FD6-0832-C3DD-98C7-744026915E58}"/>
              </a:ext>
            </a:extLst>
          </p:cNvPr>
          <p:cNvSpPr txBox="1"/>
          <p:nvPr/>
        </p:nvSpPr>
        <p:spPr>
          <a:xfrm>
            <a:off x="2719945" y="2504300"/>
            <a:ext cx="2232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FF5B1E4E-5B73-F586-F244-543095C71D88}"/>
              </a:ext>
            </a:extLst>
          </p:cNvPr>
          <p:cNvSpPr txBox="1"/>
          <p:nvPr/>
        </p:nvSpPr>
        <p:spPr>
          <a:xfrm>
            <a:off x="2309741" y="2625355"/>
            <a:ext cx="3504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A71A45A-14FF-DE68-4E38-3EBA9101B9E3}"/>
              </a:ext>
            </a:extLst>
          </p:cNvPr>
          <p:cNvSpPr txBox="1"/>
          <p:nvPr/>
        </p:nvSpPr>
        <p:spPr>
          <a:xfrm>
            <a:off x="1858388" y="2699006"/>
            <a:ext cx="2232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AA326E46-986D-CF08-8229-FE2372225387}"/>
              </a:ext>
            </a:extLst>
          </p:cNvPr>
          <p:cNvSpPr txBox="1"/>
          <p:nvPr/>
        </p:nvSpPr>
        <p:spPr>
          <a:xfrm>
            <a:off x="2786481" y="2699006"/>
            <a:ext cx="2232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5A9E510F-F3B7-1F9A-6B1B-ACFB00F121E8}"/>
              </a:ext>
            </a:extLst>
          </p:cNvPr>
          <p:cNvSpPr txBox="1"/>
          <p:nvPr/>
        </p:nvSpPr>
        <p:spPr>
          <a:xfrm>
            <a:off x="1662839" y="2845629"/>
            <a:ext cx="2232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055A24B2-36E7-A0D6-429C-87CBA69C9C72}"/>
              </a:ext>
            </a:extLst>
          </p:cNvPr>
          <p:cNvSpPr txBox="1"/>
          <p:nvPr/>
        </p:nvSpPr>
        <p:spPr>
          <a:xfrm>
            <a:off x="3009738" y="2845629"/>
            <a:ext cx="2232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4D8B7BEC-858D-380C-2D9A-46631B0A3373}"/>
              </a:ext>
            </a:extLst>
          </p:cNvPr>
          <p:cNvSpPr txBox="1"/>
          <p:nvPr/>
        </p:nvSpPr>
        <p:spPr>
          <a:xfrm>
            <a:off x="2081939" y="2858692"/>
            <a:ext cx="2232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F7A6ED02-03EA-36A2-D9E6-7D42ACE62F62}"/>
              </a:ext>
            </a:extLst>
          </p:cNvPr>
          <p:cNvSpPr txBox="1"/>
          <p:nvPr/>
        </p:nvSpPr>
        <p:spPr>
          <a:xfrm>
            <a:off x="2329589" y="3119042"/>
            <a:ext cx="2232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8175B5D8-56BA-2816-CB13-831CFEB50204}"/>
              </a:ext>
            </a:extLst>
          </p:cNvPr>
          <p:cNvSpPr txBox="1"/>
          <p:nvPr/>
        </p:nvSpPr>
        <p:spPr>
          <a:xfrm>
            <a:off x="2583589" y="2858692"/>
            <a:ext cx="2232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1D620FCF-F351-87BE-EB20-EDC2B01B6CBD}"/>
              </a:ext>
            </a:extLst>
          </p:cNvPr>
          <p:cNvSpPr txBox="1"/>
          <p:nvPr/>
        </p:nvSpPr>
        <p:spPr>
          <a:xfrm>
            <a:off x="2507389" y="3290492"/>
            <a:ext cx="2232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ECB6313B-73DE-AEF9-D01A-A09710EA526F}"/>
              </a:ext>
            </a:extLst>
          </p:cNvPr>
          <p:cNvSpPr txBox="1"/>
          <p:nvPr/>
        </p:nvSpPr>
        <p:spPr>
          <a:xfrm>
            <a:off x="2100989" y="3290492"/>
            <a:ext cx="2232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BE23C158-2C50-8D08-56A8-475F6496753D}"/>
              </a:ext>
            </a:extLst>
          </p:cNvPr>
          <p:cNvSpPr txBox="1"/>
          <p:nvPr/>
        </p:nvSpPr>
        <p:spPr>
          <a:xfrm>
            <a:off x="2309741" y="3430114"/>
            <a:ext cx="4254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6623AAD0-A66C-DD14-BE34-DAE66EB42A7F}"/>
              </a:ext>
            </a:extLst>
          </p:cNvPr>
          <p:cNvSpPr txBox="1"/>
          <p:nvPr/>
        </p:nvSpPr>
        <p:spPr>
          <a:xfrm>
            <a:off x="2697099" y="3176317"/>
            <a:ext cx="3504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8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6B5E0B1E-66A2-BEE2-C75B-45480056B73E}"/>
              </a:ext>
            </a:extLst>
          </p:cNvPr>
          <p:cNvSpPr txBox="1"/>
          <p:nvPr/>
        </p:nvSpPr>
        <p:spPr>
          <a:xfrm>
            <a:off x="1874760" y="3133762"/>
            <a:ext cx="3504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87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44DDC95B-690A-664A-0519-C8AFD945C80C}"/>
              </a:ext>
            </a:extLst>
          </p:cNvPr>
          <p:cNvSpPr txBox="1"/>
          <p:nvPr/>
        </p:nvSpPr>
        <p:spPr>
          <a:xfrm>
            <a:off x="1171300" y="3609994"/>
            <a:ext cx="14981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R-up &amp; PLT-repressed (143)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0FF9F5D6-05A0-8DB1-3DFD-9D3783ED648E}"/>
              </a:ext>
            </a:extLst>
          </p:cNvPr>
          <p:cNvSpPr txBox="1"/>
          <p:nvPr/>
        </p:nvSpPr>
        <p:spPr>
          <a:xfrm>
            <a:off x="1216125" y="2112021"/>
            <a:ext cx="14845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R-down &amp; PLT-activated </a:t>
            </a:r>
          </a:p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87)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6A54018D-2005-F03A-64B1-9313D8D6FD55}"/>
              </a:ext>
            </a:extLst>
          </p:cNvPr>
          <p:cNvSpPr txBox="1"/>
          <p:nvPr/>
        </p:nvSpPr>
        <p:spPr>
          <a:xfrm>
            <a:off x="2713928" y="2112021"/>
            <a:ext cx="7270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rought-up </a:t>
            </a:r>
          </a:p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106)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029BF8AE-AF3B-E6D5-5C71-1C1A77F76C14}"/>
              </a:ext>
            </a:extLst>
          </p:cNvPr>
          <p:cNvSpPr txBox="1"/>
          <p:nvPr/>
        </p:nvSpPr>
        <p:spPr>
          <a:xfrm>
            <a:off x="2723927" y="3597987"/>
            <a:ext cx="8312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rought-down</a:t>
            </a:r>
          </a:p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124)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3BB9A1A6-0A6D-2783-2325-F352B38A6DBC}"/>
              </a:ext>
            </a:extLst>
          </p:cNvPr>
          <p:cNvSpPr txBox="1"/>
          <p:nvPr/>
        </p:nvSpPr>
        <p:spPr>
          <a:xfrm>
            <a:off x="627994" y="4115103"/>
            <a:ext cx="537954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 3</a:t>
            </a:r>
          </a:p>
          <a:p>
            <a:pPr algn="just"/>
            <a:r>
              <a:rPr lang="en-US" altLang="zh-CN" sz="12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regulated genes analysis of BR,</a:t>
            </a:r>
            <a:r>
              <a:rPr lang="zh-CN" altLang="en-US" sz="12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2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LT1/PLT2, and drought. (</a:t>
            </a:r>
            <a:r>
              <a:rPr lang="en-US" altLang="zh-CN" sz="1200" b="1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altLang="zh-CN" sz="12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) Venn diagrams of  BR, PLT1/PLT2, and drought-regulated genes. (</a:t>
            </a:r>
            <a:r>
              <a:rPr lang="en-US" altLang="zh-CN" sz="1200" b="1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</a:t>
            </a:r>
            <a:r>
              <a:rPr lang="en-US" altLang="zh-CN" sz="12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) GO classification of the 75 regulated genes.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1668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13</TotalTime>
  <Words>306</Words>
  <Application>Microsoft Office PowerPoint</Application>
  <PresentationFormat>A4 纸张(210x297 毫米)</PresentationFormat>
  <Paragraphs>58</Paragraphs>
  <Slides>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uxuedan</dc:creator>
  <cp:lastModifiedBy>Baowen Zhang</cp:lastModifiedBy>
  <cp:revision>147</cp:revision>
  <dcterms:created xsi:type="dcterms:W3CDTF">2021-10-12T12:54:26Z</dcterms:created>
  <dcterms:modified xsi:type="dcterms:W3CDTF">2023-04-20T13:07:27Z</dcterms:modified>
</cp:coreProperties>
</file>